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DFD9F-261C-435D-A5AA-60779054EF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9FBCF-B806-4EC4-A13F-FE276ABB15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9E27C-AD65-4B28-9AD8-392ADB816A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F8F0A-8DD8-4930-9975-3F1496D082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B65D3-7C65-4607-921E-B751D9FA00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A59E7-37C5-4AC1-85CC-A5AAB58F21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3AAEB-9F02-4295-8F04-7DD2F35A78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A0414-F101-4B4F-80A0-98691F9076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A0520-5ECE-4DC9-B9C2-1B5544905C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AE442-C06A-4342-84BE-42C7E5F667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CDD23-514D-4DD7-98B0-4F9A801ED7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F3D52-B151-4F78-9392-FF68D4AD73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4DA14A-8A29-4803-BD3C-E901A21A0F1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914400" y="457200"/>
            <a:ext cx="5578560" cy="8153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380880" y="304920"/>
            <a:ext cx="3005280" cy="396216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2"/>
          <a:stretch/>
        </p:blipFill>
        <p:spPr>
          <a:xfrm>
            <a:off x="3886200" y="380880"/>
            <a:ext cx="2614680" cy="418644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3352680" y="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3"/>
          <a:stretch/>
        </p:blipFill>
        <p:spPr>
          <a:xfrm>
            <a:off x="457200" y="4648320"/>
            <a:ext cx="2770200" cy="41148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0" y="434340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4"/>
          <a:stretch/>
        </p:blipFill>
        <p:spPr>
          <a:xfrm>
            <a:off x="3352680" y="4724280"/>
            <a:ext cx="2919600" cy="335448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429000" y="441972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380880" y="533520"/>
            <a:ext cx="5989680" cy="784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685800" y="457200"/>
            <a:ext cx="5597640" cy="7848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1295280" y="380880"/>
            <a:ext cx="4343400" cy="326880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"/>
          <a:stretch/>
        </p:blipFill>
        <p:spPr>
          <a:xfrm>
            <a:off x="990720" y="4267080"/>
            <a:ext cx="4876560" cy="402444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304920" y="403848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04920" y="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852480" y="304920"/>
            <a:ext cx="552600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"/>
          <p:cNvSpPr/>
          <p:nvPr/>
        </p:nvSpPr>
        <p:spPr>
          <a:xfrm>
            <a:off x="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505320" y="0"/>
            <a:ext cx="7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914400" y="419112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304920" y="380880"/>
            <a:ext cx="3835440" cy="334332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2"/>
          <a:stretch/>
        </p:blipFill>
        <p:spPr>
          <a:xfrm>
            <a:off x="4038480" y="457200"/>
            <a:ext cx="2502000" cy="198432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3"/>
          <a:stretch/>
        </p:blipFill>
        <p:spPr>
          <a:xfrm>
            <a:off x="1752480" y="3809880"/>
            <a:ext cx="4218120" cy="5334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8T23:53:00Z</dcterms:created>
  <dc:creator>Ming Yi</dc:creator>
  <dc:description/>
  <dc:language>en-US</dc:language>
  <cp:lastModifiedBy>Ming Yi</cp:lastModifiedBy>
  <dcterms:modified xsi:type="dcterms:W3CDTF">2012-02-09T06:49:38Z</dcterms:modified>
  <cp:revision>7</cp:revision>
  <dc:subject/>
  <dc:title>Slide 1</dc:title>
</cp:coreProperties>
</file>